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0"/>
  </p:notesMasterIdLst>
  <p:sldIdLst>
    <p:sldId id="256" r:id="rId2"/>
    <p:sldId id="263" r:id="rId3"/>
    <p:sldId id="264" r:id="rId4"/>
    <p:sldId id="265" r:id="rId5"/>
    <p:sldId id="266" r:id="rId6"/>
    <p:sldId id="261" r:id="rId7"/>
    <p:sldId id="267" r:id="rId8"/>
    <p:sldId id="268" r:id="rId9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hNz1G5BWHp02AhwDto0ElJhQD72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280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customschemas.google.com/relationships/presentationmetadata" Target="meta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Google Shape;225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226" name="Google Shape;226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4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5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5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6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6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4" name="Google Shape;24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2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2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3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3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u-HU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_schierenbeck@hotmail.com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mailto:ahqudah@gmail.com" TargetMode="External"/><Relationship Id="rId4" Type="http://schemas.openxmlformats.org/officeDocument/2006/relationships/hyperlink" Target="mailto:aalqudah@qu.edu.qa" TargetMode="Externa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7.png"/><Relationship Id="rId4" Type="http://schemas.openxmlformats.org/officeDocument/2006/relationships/image" Target="../media/image6.jp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/>
          <p:nvPr/>
        </p:nvSpPr>
        <p:spPr>
          <a:xfrm>
            <a:off x="375821" y="310724"/>
            <a:ext cx="11751076" cy="2692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hu-HU" sz="1400" b="1" i="1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Natural allelic variation confers diversity in the regulation of flag leaf traits in wheat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1" i="1" u="none" strike="noStrike" cap="none" dirty="0">
                <a:solidFill>
                  <a:srgbClr val="333333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 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1" i="1" u="none" strike="noStrike" cap="none" dirty="0">
                <a:solidFill>
                  <a:srgbClr val="333333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 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1" i="0" u="sng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atías Schierenbeck</a:t>
            </a:r>
            <a:r>
              <a:rPr lang="hu-HU" sz="1100" b="1" i="0" u="none" strike="noStrike" cap="none" baseline="300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1,2,3</a:t>
            </a:r>
            <a:r>
              <a:rPr lang="hu-HU" sz="11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*, Ahmad M. Alqudah</a:t>
            </a:r>
            <a:r>
              <a:rPr lang="hu-HU" sz="1100" b="1" i="0" u="none" strike="noStrike" cap="none" baseline="300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4</a:t>
            </a:r>
            <a:r>
              <a:rPr lang="hu-HU" sz="1100" b="1" i="0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*</a:t>
            </a:r>
            <a:r>
              <a:rPr lang="hu-HU" sz="11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hu-HU" sz="11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amar G. Thabet</a:t>
            </a:r>
            <a:r>
              <a:rPr lang="hu-HU" sz="1100" b="1" i="0" u="none" strike="noStrike" cap="none" baseline="300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5</a:t>
            </a:r>
            <a:r>
              <a:rPr lang="hu-HU" sz="11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Evangelina G. Avogadro</a:t>
            </a:r>
            <a:r>
              <a:rPr lang="hu-HU" sz="1100" b="1" i="0" u="none" strike="noStrike" cap="none" baseline="300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1</a:t>
            </a:r>
            <a:r>
              <a:rPr lang="hu-HU" sz="11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Juan Ignacio Dietz</a:t>
            </a:r>
            <a:r>
              <a:rPr lang="hu-HU" sz="1100" b="1" i="0" u="none" strike="noStrike" cap="none" baseline="300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3,6</a:t>
            </a:r>
            <a:r>
              <a:rPr lang="hu-HU" sz="11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María Rosa Simón</a:t>
            </a:r>
            <a:r>
              <a:rPr lang="hu-HU" sz="1100" b="1" i="0" u="none" strike="noStrike" cap="none" baseline="300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2,3</a:t>
            </a:r>
            <a:r>
              <a:rPr lang="hu-HU" sz="11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and Andreas Börner</a:t>
            </a:r>
            <a:r>
              <a:rPr lang="hu-HU" sz="1100" b="1" i="0" u="none" strike="noStrike" cap="none" baseline="300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1</a:t>
            </a:r>
            <a:r>
              <a:rPr lang="hu-HU" sz="11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0" i="0" strike="noStrike" cap="none" baseline="30000" dirty="0">
                <a:solidFill>
                  <a:schemeClr val="tx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1 </a:t>
            </a:r>
            <a:r>
              <a:rPr lang="es-AR" sz="1100" b="0" i="0" strike="noStrike" cap="none" dirty="0" err="1">
                <a:solidFill>
                  <a:schemeClr val="tx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enebank</a:t>
            </a:r>
            <a:r>
              <a:rPr lang="es-AR" sz="1100" b="0" i="0" strike="noStrike" cap="none" dirty="0">
                <a:solidFill>
                  <a:schemeClr val="tx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AR" sz="1100" b="0" i="0" strike="noStrike" cap="none" dirty="0" err="1">
                <a:solidFill>
                  <a:schemeClr val="tx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epartment</a:t>
            </a:r>
            <a:r>
              <a:rPr lang="es-AR" sz="1100" b="0" i="0" strike="noStrike" cap="none" dirty="0">
                <a:solidFill>
                  <a:schemeClr val="tx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Leibniz Institute of Plant Genetics and Crop Plant Research (IPK), OT Gatersleben, Corrensstr</a:t>
            </a:r>
            <a:r>
              <a:rPr lang="es-AR" sz="11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3, D-06466 Seeland, Germany. 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0" i="0" u="none" strike="noStrike" cap="none" baseline="30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2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Faculty of Agricultural Sciences and Forestry, National University of La Plata, La Plata, Argentina. 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0" i="0" u="none" strike="noStrike" cap="none" baseline="30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3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CONICET CCT La Plata. La Plata, Argentina. 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0" i="0" u="none" strike="noStrike" cap="none" baseline="30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4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Biological Science Program, Department of Biological and Environmental Sciences, College of Art and Science, Qatar University, Doha, Qatar 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0" i="0" u="none" strike="noStrike" cap="none" baseline="30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5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epartment of Botany, Faculty of Science, Fayoum University, Egypt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just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0" i="0" u="none" strike="noStrike" cap="none" baseline="300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6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EA INTA Bordenave. Ruta 76 km 36. Bordenave, Argentina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*corresponding author email: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lnSpc>
                <a:spcPct val="107000"/>
              </a:lnSpc>
              <a:spcBef>
                <a:spcPts val="80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1" i="0" u="sng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atías Schierenbeck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 </a:t>
            </a:r>
            <a:r>
              <a:rPr lang="hu-HU" sz="1100" b="0" i="0" u="sng" strike="noStrike" cap="none" dirty="0">
                <a:solidFill>
                  <a:srgbClr val="0000FF"/>
                </a:solidFill>
                <a:latin typeface="Times New Roman"/>
                <a:ea typeface="Times New Roman"/>
                <a:cs typeface="Times New Roman"/>
                <a:sym typeface="Times New Roman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m_schierenbeck@hotmail.com</a:t>
            </a:r>
            <a:r>
              <a:rPr lang="hu-HU" sz="1100" b="0" i="0" u="sng" strike="noStrike" cap="none" dirty="0">
                <a:solidFill>
                  <a:srgbClr val="0000FF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; schierenbeck@ipk-gatersleben.de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lnSpc>
                <a:spcPct val="107000"/>
              </a:lnSpc>
              <a:spcBef>
                <a:spcPts val="80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hmad M. Alqudah</a:t>
            </a:r>
            <a:r>
              <a:rPr lang="hu-HU" sz="1100" b="1" i="0" u="none" strike="noStrike" cap="none" baseline="300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hu-HU" sz="1100" b="0" i="0" u="sng" strike="noStrike" cap="none" dirty="0">
                <a:solidFill>
                  <a:srgbClr val="0000FF"/>
                </a:solidFill>
                <a:latin typeface="Times New Roman"/>
                <a:ea typeface="Times New Roman"/>
                <a:cs typeface="Times New Roman"/>
                <a:sym typeface="Times New Roman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aalqudah@qu.edu.qa</a:t>
            </a:r>
            <a:r>
              <a:rPr lang="hu-HU" sz="11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; </a:t>
            </a:r>
            <a:r>
              <a:rPr lang="hu-HU" sz="1100" b="1" i="0" u="none" strike="noStrike" cap="none" baseline="300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hu-HU" sz="1100" b="0" i="0" u="sng" strike="noStrike" cap="none" dirty="0">
                <a:solidFill>
                  <a:srgbClr val="0000FF"/>
                </a:solidFill>
                <a:latin typeface="Times New Roman"/>
                <a:ea typeface="Times New Roman"/>
                <a:cs typeface="Times New Roman"/>
                <a:sym typeface="Times New Roman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ahqudah@gmail.com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159BDB74-D633-4284-9D02-6206E48FC1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884" y="292542"/>
            <a:ext cx="12033489" cy="6264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9781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5F56DDAC-55BA-4901-93E2-142252762B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09" y="255180"/>
            <a:ext cx="11929575" cy="62401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88389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D6E26AAD-D9F8-41FC-9D56-CDDDE9F39C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23" y="262269"/>
            <a:ext cx="12057322" cy="6301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79223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82DE5672-7B07-4FCE-8ECC-D6B1866602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505" y="304800"/>
            <a:ext cx="12023876" cy="62844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38416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Google Shape;228;p2"/>
          <p:cNvSpPr/>
          <p:nvPr/>
        </p:nvSpPr>
        <p:spPr>
          <a:xfrm>
            <a:off x="0" y="4204816"/>
            <a:ext cx="12192000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 algn="just">
              <a:buSzPts val="1200"/>
            </a:pPr>
            <a:r>
              <a:rPr lang="hu-HU" sz="12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igure S5. (a) Manhattan plots showing significant marker traits association for 261 winter wheat genotypes used for flag leaf parameters (FL_LWRatio)</a:t>
            </a:r>
            <a:r>
              <a:rPr lang="es-AR" sz="12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</a:t>
            </a:r>
            <a:r>
              <a:rPr lang="hu-HU" sz="12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FL: flag leaf, LW Ratio: length width Ratio</a:t>
            </a:r>
            <a:r>
              <a:rPr lang="es-AR" sz="12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 </a:t>
            </a:r>
            <a:r>
              <a:rPr lang="hu-HU" sz="12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TAs are indicated as </a:t>
            </a:r>
            <a:r>
              <a:rPr lang="hu-HU" sz="1200" b="1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-log</a:t>
            </a:r>
            <a:r>
              <a:rPr lang="hu-HU" sz="1200" b="1" baseline="-25000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10 </a:t>
            </a:r>
            <a:r>
              <a:rPr lang="hu-HU" sz="1200" b="1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(5.85e</a:t>
            </a:r>
            <a:r>
              <a:rPr lang="hu-HU" sz="1200" b="1" baseline="30000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-5</a:t>
            </a:r>
            <a:r>
              <a:rPr lang="hu-HU" sz="1200" b="1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)=4.23</a:t>
            </a:r>
            <a:r>
              <a:rPr lang="hu-HU" sz="12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with gene structure at chromosome 2A. (b) QTN -gene haplotype analysis (**p&lt;0.05; ***p&lt;0.001). </a:t>
            </a:r>
            <a:endParaRPr sz="1200" b="1" i="0" u="none" strike="noStrike" cap="none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grpSp>
        <p:nvGrpSpPr>
          <p:cNvPr id="229" name="Google Shape;229;p2"/>
          <p:cNvGrpSpPr/>
          <p:nvPr/>
        </p:nvGrpSpPr>
        <p:grpSpPr>
          <a:xfrm>
            <a:off x="439716" y="3240314"/>
            <a:ext cx="6831096" cy="731353"/>
            <a:chOff x="322791" y="3268925"/>
            <a:chExt cx="6831096" cy="731353"/>
          </a:xfrm>
        </p:grpSpPr>
        <p:grpSp>
          <p:nvGrpSpPr>
            <p:cNvPr id="230" name="Google Shape;230;p2"/>
            <p:cNvGrpSpPr/>
            <p:nvPr/>
          </p:nvGrpSpPr>
          <p:grpSpPr>
            <a:xfrm>
              <a:off x="3185568" y="3626067"/>
              <a:ext cx="3968319" cy="374211"/>
              <a:chOff x="3564541" y="3944753"/>
              <a:chExt cx="4681679" cy="429095"/>
            </a:xfrm>
          </p:grpSpPr>
          <p:sp>
            <p:nvSpPr>
              <p:cNvPr id="231" name="Google Shape;231;p2"/>
              <p:cNvSpPr/>
              <p:nvPr/>
            </p:nvSpPr>
            <p:spPr>
              <a:xfrm>
                <a:off x="3564541" y="4056269"/>
                <a:ext cx="4681679" cy="31757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hu-HU" sz="1200" b="1" i="0" u="none" strike="noStrike" cap="none">
                    <a:solidFill>
                      <a:srgbClr val="7030A0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rPr>
                  <a:t>RFL_Contig5625_2578 (</a:t>
                </a:r>
                <a:r>
                  <a:rPr lang="hu-HU" sz="1200" b="1" i="0" u="none" strike="noStrike" cap="none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rPr>
                  <a:t>FLR; 2A; IWB65061; 25.97cM)</a:t>
                </a:r>
                <a:endParaRPr sz="1400" b="0" i="0" u="none" strike="noStrike" cap="none">
                  <a:solidFill>
                    <a:srgbClr val="000000"/>
                  </a:solidFill>
                  <a:latin typeface="Times New Roman"/>
                  <a:ea typeface="Times New Roman"/>
                  <a:cs typeface="Times New Roman"/>
                  <a:sym typeface="Times New Roman"/>
                </a:endParaRPr>
              </a:p>
            </p:txBody>
          </p:sp>
          <p:cxnSp>
            <p:nvCxnSpPr>
              <p:cNvPr id="232" name="Google Shape;232;p2"/>
              <p:cNvCxnSpPr/>
              <p:nvPr/>
            </p:nvCxnSpPr>
            <p:spPr>
              <a:xfrm rot="10800000">
                <a:off x="6280051" y="3944753"/>
                <a:ext cx="0" cy="193738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</p:grpSp>
        <p:pic>
          <p:nvPicPr>
            <p:cNvPr id="233" name="Google Shape;233;p2" descr="http://plants.ensembl.org/img-tmp/temporary/2022_07_22/MLNEHVYSdBIdABEPQEAACKRD.png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322791" y="3268925"/>
              <a:ext cx="6622448" cy="384585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234" name="Google Shape;234;p2"/>
          <p:cNvGrpSpPr/>
          <p:nvPr/>
        </p:nvGrpSpPr>
        <p:grpSpPr>
          <a:xfrm>
            <a:off x="93340" y="125458"/>
            <a:ext cx="7315200" cy="3135086"/>
            <a:chOff x="158461" y="144588"/>
            <a:chExt cx="7315200" cy="3135086"/>
          </a:xfrm>
        </p:grpSpPr>
        <p:grpSp>
          <p:nvGrpSpPr>
            <p:cNvPr id="235" name="Google Shape;235;p2"/>
            <p:cNvGrpSpPr/>
            <p:nvPr/>
          </p:nvGrpSpPr>
          <p:grpSpPr>
            <a:xfrm>
              <a:off x="158461" y="144588"/>
              <a:ext cx="7315200" cy="3135086"/>
              <a:chOff x="158461" y="144588"/>
              <a:chExt cx="7315200" cy="3135086"/>
            </a:xfrm>
          </p:grpSpPr>
          <p:grpSp>
            <p:nvGrpSpPr>
              <p:cNvPr id="236" name="Google Shape;236;p2"/>
              <p:cNvGrpSpPr/>
              <p:nvPr/>
            </p:nvGrpSpPr>
            <p:grpSpPr>
              <a:xfrm>
                <a:off x="158461" y="144588"/>
                <a:ext cx="7315200" cy="3135086"/>
                <a:chOff x="0" y="338908"/>
                <a:chExt cx="7315200" cy="3135086"/>
              </a:xfrm>
            </p:grpSpPr>
            <p:pic>
              <p:nvPicPr>
                <p:cNvPr id="237" name="Google Shape;237;p2"/>
                <p:cNvPicPr preferRelativeResize="0"/>
                <p:nvPr/>
              </p:nvPicPr>
              <p:blipFill rotWithShape="1">
                <a:blip r:embed="rId4">
                  <a:alphaModFix/>
                </a:blip>
                <a:srcRect/>
                <a:stretch/>
              </p:blipFill>
              <p:spPr>
                <a:xfrm>
                  <a:off x="0" y="338908"/>
                  <a:ext cx="7315200" cy="3135086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238" name="Google Shape;238;p2"/>
                <p:cNvSpPr/>
                <p:nvPr/>
              </p:nvSpPr>
              <p:spPr>
                <a:xfrm>
                  <a:off x="949964" y="690706"/>
                  <a:ext cx="1950990" cy="30773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400"/>
                    <a:buFont typeface="Arial"/>
                    <a:buNone/>
                  </a:pPr>
                  <a:r>
                    <a:rPr lang="hu-HU" sz="1400" b="1" i="0" u="none" strike="noStrike" cap="none" dirty="0">
                      <a:solidFill>
                        <a:schemeClr val="dk1"/>
                      </a:solidFill>
                      <a:latin typeface="Times New Roman"/>
                      <a:ea typeface="Times New Roman"/>
                      <a:cs typeface="Times New Roman"/>
                      <a:sym typeface="Times New Roman"/>
                    </a:rPr>
                    <a:t>RFL_Contig5625_2578</a:t>
                  </a:r>
                  <a:endParaRPr sz="1400" b="0" i="0" u="none" strike="noStrike" cap="none" dirty="0">
                    <a:solidFill>
                      <a:srgbClr val="000000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endParaRPr>
                </a:p>
              </p:txBody>
            </p:sp>
          </p:grpSp>
          <p:sp>
            <p:nvSpPr>
              <p:cNvPr id="239" name="Google Shape;239;p2"/>
              <p:cNvSpPr txBox="1"/>
              <p:nvPr/>
            </p:nvSpPr>
            <p:spPr>
              <a:xfrm>
                <a:off x="199101" y="478406"/>
                <a:ext cx="481230" cy="2769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hu-HU" sz="1200" b="1" i="0" u="none" strike="noStrike" cap="none">
                    <a:solidFill>
                      <a:schemeClr val="dk1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rPr>
                  <a:t>(a)</a:t>
                </a:r>
                <a:endParaRPr sz="1400" b="0" i="0" u="none" strike="noStrike" cap="none">
                  <a:solidFill>
                    <a:srgbClr val="000000"/>
                  </a:solidFill>
                  <a:latin typeface="Times New Roman"/>
                  <a:ea typeface="Times New Roman"/>
                  <a:cs typeface="Times New Roman"/>
                  <a:sym typeface="Times New Roman"/>
                </a:endParaRPr>
              </a:p>
            </p:txBody>
          </p:sp>
        </p:grpSp>
        <p:cxnSp>
          <p:nvCxnSpPr>
            <p:cNvPr id="240" name="Google Shape;240;p2"/>
            <p:cNvCxnSpPr>
              <a:cxnSpLocks/>
            </p:cNvCxnSpPr>
            <p:nvPr/>
          </p:nvCxnSpPr>
          <p:spPr>
            <a:xfrm>
              <a:off x="790113" y="1438183"/>
              <a:ext cx="6295054" cy="0"/>
            </a:xfrm>
            <a:prstGeom prst="straightConnector1">
              <a:avLst/>
            </a:prstGeom>
            <a:noFill/>
            <a:ln w="19050" cap="flat" cmpd="sng">
              <a:solidFill>
                <a:srgbClr val="C0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41" name="Google Shape;241;p2"/>
          <p:cNvSpPr txBox="1"/>
          <p:nvPr/>
        </p:nvSpPr>
        <p:spPr>
          <a:xfrm>
            <a:off x="255318" y="3000854"/>
            <a:ext cx="1148080" cy="220752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hu-HU" sz="11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r.2A (Mb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242" name="Google Shape;242;p2"/>
          <p:cNvGrpSpPr/>
          <p:nvPr/>
        </p:nvGrpSpPr>
        <p:grpSpPr>
          <a:xfrm>
            <a:off x="7851870" y="478406"/>
            <a:ext cx="4093798" cy="3426811"/>
            <a:chOff x="7851870" y="478406"/>
            <a:chExt cx="4093798" cy="3426811"/>
          </a:xfrm>
        </p:grpSpPr>
        <p:sp>
          <p:nvSpPr>
            <p:cNvPr id="243" name="Google Shape;243;p2"/>
            <p:cNvSpPr txBox="1"/>
            <p:nvPr/>
          </p:nvSpPr>
          <p:spPr>
            <a:xfrm>
              <a:off x="8309368" y="3289694"/>
              <a:ext cx="3636300" cy="61552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hu-HU" sz="1400" b="0" i="0" u="none" strike="noStrike" cap="none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Hap 1 (A): 247 genotypes</a:t>
              </a:r>
              <a:endParaRPr sz="14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hu-HU" sz="1400" b="1" i="0" u="none" strike="noStrike" cap="none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Hap 2 (G): 14 genotypes</a:t>
              </a:r>
              <a:endParaRPr sz="1400" b="1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endParaRPr>
            </a:p>
          </p:txBody>
        </p:sp>
        <p:grpSp>
          <p:nvGrpSpPr>
            <p:cNvPr id="244" name="Google Shape;244;p2"/>
            <p:cNvGrpSpPr/>
            <p:nvPr/>
          </p:nvGrpSpPr>
          <p:grpSpPr>
            <a:xfrm>
              <a:off x="7851870" y="478406"/>
              <a:ext cx="3085939" cy="2877738"/>
              <a:chOff x="7851870" y="478406"/>
              <a:chExt cx="3085939" cy="2877738"/>
            </a:xfrm>
          </p:grpSpPr>
          <p:grpSp>
            <p:nvGrpSpPr>
              <p:cNvPr id="245" name="Google Shape;245;p2"/>
              <p:cNvGrpSpPr/>
              <p:nvPr/>
            </p:nvGrpSpPr>
            <p:grpSpPr>
              <a:xfrm>
                <a:off x="7851870" y="478406"/>
                <a:ext cx="3085939" cy="2877738"/>
                <a:chOff x="7953994" y="478406"/>
                <a:chExt cx="2983815" cy="2743200"/>
              </a:xfrm>
            </p:grpSpPr>
            <p:pic>
              <p:nvPicPr>
                <p:cNvPr id="246" name="Google Shape;246;p2"/>
                <p:cNvPicPr preferRelativeResize="0"/>
                <p:nvPr/>
              </p:nvPicPr>
              <p:blipFill rotWithShape="1">
                <a:blip r:embed="rId5">
                  <a:alphaModFix/>
                </a:blip>
                <a:srcRect/>
                <a:stretch/>
              </p:blipFill>
              <p:spPr>
                <a:xfrm>
                  <a:off x="8194609" y="478406"/>
                  <a:ext cx="2743200" cy="274320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247" name="Google Shape;247;p2"/>
                <p:cNvSpPr txBox="1"/>
                <p:nvPr/>
              </p:nvSpPr>
              <p:spPr>
                <a:xfrm>
                  <a:off x="7953994" y="516523"/>
                  <a:ext cx="481230" cy="276998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200"/>
                    <a:buFont typeface="Arial"/>
                    <a:buNone/>
                  </a:pPr>
                  <a:r>
                    <a:rPr lang="hu-HU" sz="1200" b="1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(b)</a:t>
                  </a:r>
                  <a:endParaRPr sz="14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sp>
            <p:nvSpPr>
              <p:cNvPr id="248" name="Google Shape;248;p2"/>
              <p:cNvSpPr txBox="1"/>
              <p:nvPr/>
            </p:nvSpPr>
            <p:spPr>
              <a:xfrm>
                <a:off x="9444484" y="663683"/>
                <a:ext cx="590133" cy="215444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hu-HU" sz="800" b="1" i="0" u="none" strike="noStrike" cap="none">
                    <a:solidFill>
                      <a:srgbClr val="000000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rPr>
                  <a:t>***</a:t>
                </a:r>
                <a:endParaRPr sz="800" b="1" i="0" u="none" strike="noStrike" cap="none">
                  <a:solidFill>
                    <a:srgbClr val="000000"/>
                  </a:solidFill>
                  <a:latin typeface="Times New Roman"/>
                  <a:ea typeface="Times New Roman"/>
                  <a:cs typeface="Times New Roman"/>
                  <a:sym typeface="Times New Roman"/>
                </a:endParaRPr>
              </a:p>
            </p:txBody>
          </p:sp>
        </p:grpSp>
      </p:grpSp>
      <p:cxnSp>
        <p:nvCxnSpPr>
          <p:cNvPr id="23" name="Google Shape;210;g2de2cf688b7_0_96">
            <a:extLst>
              <a:ext uri="{FF2B5EF4-FFF2-40B4-BE49-F238E27FC236}">
                <a16:creationId xmlns:a16="http://schemas.microsoft.com/office/drawing/2014/main" id="{DE6D9804-14F4-4E55-84C6-FD5E491A2ED7}"/>
              </a:ext>
            </a:extLst>
          </p:cNvPr>
          <p:cNvCxnSpPr>
            <a:cxnSpLocks/>
          </p:cNvCxnSpPr>
          <p:nvPr/>
        </p:nvCxnSpPr>
        <p:spPr>
          <a:xfrm flipH="1">
            <a:off x="951227" y="618074"/>
            <a:ext cx="107313" cy="118200"/>
          </a:xfrm>
          <a:prstGeom prst="straightConnector1">
            <a:avLst/>
          </a:prstGeom>
          <a:noFill/>
          <a:ln w="2857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9780B8B5-99EE-4C2A-B2A9-62A435A219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245" y="1036674"/>
            <a:ext cx="12056755" cy="47846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01077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B88304E3-4B3C-4BE8-94FE-4F5AC6EB45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93" y="964019"/>
            <a:ext cx="12141878" cy="4926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795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Office PowerPoint</Application>
  <PresentationFormat>Panorámica</PresentationFormat>
  <Paragraphs>22</Paragraphs>
  <Slides>8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Them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mar</dc:creator>
  <cp:lastModifiedBy>Matías Schierenbeck</cp:lastModifiedBy>
  <cp:revision>4</cp:revision>
  <dcterms:created xsi:type="dcterms:W3CDTF">2023-05-18T08:13:22Z</dcterms:created>
  <dcterms:modified xsi:type="dcterms:W3CDTF">2024-06-08T10:25:48Z</dcterms:modified>
</cp:coreProperties>
</file>